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/>
    <p:restoredTop sz="86442"/>
  </p:normalViewPr>
  <p:slideViewPr>
    <p:cSldViewPr snapToGrid="0" snapToObjects="1">
      <p:cViewPr>
        <p:scale>
          <a:sx n="100" d="100"/>
          <a:sy n="100" d="100"/>
        </p:scale>
        <p:origin x="-712" y="-144"/>
      </p:cViewPr>
      <p:guideLst>
        <p:guide orient="horz" pos="2552"/>
        <p:guide pos="22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5121D8-7434-8943-9FA3-C7FFC3853C58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9FF86D-3B0E-3644-A628-55750BCAD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90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84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67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39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43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3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94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40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67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7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46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eg"/><Relationship Id="rId5" Type="http://schemas.microsoft.com/office/2007/relationships/hdphoto" Target="../media/hdphoto1.wdp"/><Relationship Id="rId6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223" y="18596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2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11584" y="76383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F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490029" y="69031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8385712" y="362800"/>
            <a:ext cx="3078493" cy="4806997"/>
            <a:chOff x="6157804" y="398058"/>
            <a:chExt cx="3078493" cy="4806997"/>
          </a:xfrm>
        </p:grpSpPr>
        <p:sp>
          <p:nvSpPr>
            <p:cNvPr id="12" name="TextBox 11"/>
            <p:cNvSpPr txBox="1"/>
            <p:nvPr/>
          </p:nvSpPr>
          <p:spPr>
            <a:xfrm>
              <a:off x="6157804" y="2804577"/>
              <a:ext cx="12010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JARID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262121" y="4400059"/>
              <a:ext cx="120109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i-GAPD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6983680" y="398058"/>
              <a:ext cx="2252617" cy="4806997"/>
              <a:chOff x="6983680" y="986993"/>
              <a:chExt cx="2252617" cy="4806997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35" t="23369"/>
              <a:stretch/>
            </p:blipFill>
            <p:spPr>
              <a:xfrm>
                <a:off x="7549429" y="2371240"/>
                <a:ext cx="1279741" cy="2185261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49429" y="4556502"/>
                <a:ext cx="1279741" cy="1237488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 rot="18639868">
                <a:off x="8175478" y="1586147"/>
                <a:ext cx="165997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   FL-</a:t>
                </a:r>
              </a:p>
              <a:p>
                <a:r>
                  <a:rPr lang="en-US" sz="1200" dirty="0">
                    <a:latin typeface="Arial"/>
                    <a:cs typeface="Arial"/>
                  </a:rPr>
                  <a:t>   JARID2 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8600597">
                <a:off x="7696406" y="1810399"/>
                <a:ext cx="14781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    Empty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7049523" y="2757092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250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8636970">
                <a:off x="7437319" y="1850318"/>
                <a:ext cx="10580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charset="0"/>
                    <a:ea typeface="Arial" charset="0"/>
                    <a:cs typeface="Arial" charset="0"/>
                  </a:rPr>
                  <a:t>Marker 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038886" y="3120050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130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047593" y="3555628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>
                    <a:latin typeface="Arial" charset="0"/>
                    <a:ea typeface="Arial" charset="0"/>
                    <a:cs typeface="Arial" charset="0"/>
                  </a:rPr>
                  <a:t>100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983680" y="3960209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70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041317" y="4328038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55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7052456" y="5069815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35</a:t>
                </a:r>
              </a:p>
            </p:txBody>
          </p:sp>
        </p:grpSp>
      </p:grpSp>
      <p:grpSp>
        <p:nvGrpSpPr>
          <p:cNvPr id="14" name="Group 13"/>
          <p:cNvGrpSpPr/>
          <p:nvPr/>
        </p:nvGrpSpPr>
        <p:grpSpPr>
          <a:xfrm>
            <a:off x="3913219" y="1073204"/>
            <a:ext cx="3216578" cy="3985281"/>
            <a:chOff x="255619" y="1127691"/>
            <a:chExt cx="3376408" cy="2650815"/>
          </a:xfrm>
        </p:grpSpPr>
        <p:sp>
          <p:nvSpPr>
            <p:cNvPr id="25" name="TextBox 24"/>
            <p:cNvSpPr txBox="1"/>
            <p:nvPr/>
          </p:nvSpPr>
          <p:spPr>
            <a:xfrm rot="18607435">
              <a:off x="2690179" y="1325738"/>
              <a:ext cx="6730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WT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8612053">
              <a:off x="2921796" y="1365550"/>
              <a:ext cx="54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KO1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8598710">
              <a:off x="3222289" y="1366955"/>
              <a:ext cx="5424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/>
                  <a:cs typeface="Arial"/>
                </a:rPr>
                <a:t>KO2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9829" y="1736812"/>
              <a:ext cx="1965073" cy="125502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0"/>
            <a:stretch/>
          </p:blipFill>
          <p:spPr>
            <a:xfrm>
              <a:off x="1489042" y="2993376"/>
              <a:ext cx="1985859" cy="78513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291413" y="2117334"/>
              <a:ext cx="12010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JARID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5619" y="3161226"/>
              <a:ext cx="120109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i-GAPD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130409" y="1736813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50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112572" y="1962971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130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121279" y="2196949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>
                  <a:latin typeface="Arial" charset="0"/>
                  <a:ea typeface="Arial" charset="0"/>
                  <a:cs typeface="Arial" charset="0"/>
                </a:rPr>
                <a:t>10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093366" y="2493530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7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115003" y="2753359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55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079714" y="3322738"/>
              <a:ext cx="51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35</a:t>
              </a:r>
            </a:p>
          </p:txBody>
        </p:sp>
      </p:grpSp>
      <p:sp>
        <p:nvSpPr>
          <p:cNvPr id="43" name="TextBox 42"/>
          <p:cNvSpPr txBox="1"/>
          <p:nvPr/>
        </p:nvSpPr>
        <p:spPr>
          <a:xfrm rot="18657915">
            <a:off x="4946556" y="1453006"/>
            <a:ext cx="1058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Marker 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36242" y="76383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charset="0"/>
                <a:ea typeface="Arial" charset="0"/>
                <a:cs typeface="Arial" charset="0"/>
              </a:rPr>
              <a:t>C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graphicFrame>
        <p:nvGraphicFramePr>
          <p:cNvPr id="26" name="Tab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4755762"/>
              </p:ext>
            </p:extLst>
          </p:nvPr>
        </p:nvGraphicFramePr>
        <p:xfrm>
          <a:off x="408019" y="1179902"/>
          <a:ext cx="3721100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8119"/>
                <a:gridCol w="1091133"/>
                <a:gridCol w="941134"/>
                <a:gridCol w="1230714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soform-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soform-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soform-3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5450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82720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00171565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184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40736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0289487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21562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686681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0117026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46" name="Rectangle 45"/>
          <p:cNvSpPr/>
          <p:nvPr/>
        </p:nvSpPr>
        <p:spPr>
          <a:xfrm>
            <a:off x="6158613" y="2350273"/>
            <a:ext cx="770696" cy="102876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6116508" y="4177461"/>
            <a:ext cx="839685" cy="350018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10135102" y="2297931"/>
            <a:ext cx="876372" cy="115938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10168078" y="4360930"/>
            <a:ext cx="876372" cy="298163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799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6</TotalTime>
  <Words>62</Words>
  <Application>Microsoft Macintosh PowerPoint</Application>
  <PresentationFormat>Custom</PresentationFormat>
  <Paragraphs>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a Al-Raawi</dc:creator>
  <cp:lastModifiedBy>Aditi Kanhere</cp:lastModifiedBy>
  <cp:revision>90</cp:revision>
  <dcterms:created xsi:type="dcterms:W3CDTF">2018-07-19T15:22:05Z</dcterms:created>
  <dcterms:modified xsi:type="dcterms:W3CDTF">2018-11-13T15:20:17Z</dcterms:modified>
</cp:coreProperties>
</file>